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-102" y="-18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619698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07001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529095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361641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862620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864771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867500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123251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980432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8752528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377150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339303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내용 개체 틀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99481" y="152823"/>
            <a:ext cx="4082843" cy="3121226"/>
          </a:xfr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830721" y="152823"/>
            <a:ext cx="4121965" cy="3121226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90199" y="3379908"/>
            <a:ext cx="4066398" cy="3123856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859339" y="3382537"/>
            <a:ext cx="4190713" cy="320369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9167207" y="4540054"/>
            <a:ext cx="2892829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Supplementary figure 1. ROC curve in all participants </a:t>
            </a:r>
          </a:p>
          <a:p>
            <a:endParaRPr lang="en-US" altLang="ko-KR" sz="1400" dirty="0" smtClean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2 year follow up</a:t>
            </a: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4 year follow up</a:t>
            </a: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6 year follow up</a:t>
            </a: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8 year follow up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45859" y="44335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a)</a:t>
            </a:r>
            <a:endParaRPr lang="ko-KR" alt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4689516" y="44335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b</a:t>
            </a:r>
            <a:r>
              <a:rPr lang="en-US" altLang="ko-KR" sz="1400" dirty="0" smtClean="0"/>
              <a:t>)</a:t>
            </a:r>
            <a:endParaRPr lang="ko-KR" altLang="en-US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251374" y="3274049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c</a:t>
            </a:r>
            <a:r>
              <a:rPr lang="en-US" altLang="ko-KR" sz="1400" dirty="0" smtClean="0"/>
              <a:t>)</a:t>
            </a:r>
            <a:endParaRPr lang="ko-KR" alt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4689515" y="3274049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d</a:t>
            </a:r>
            <a:r>
              <a:rPr lang="en-US" altLang="ko-KR" sz="1400" dirty="0" smtClean="0"/>
              <a:t>)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xmlns="" val="12921398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6</TotalTime>
  <Words>33</Words>
  <Application>Microsoft Office PowerPoint</Application>
  <PresentationFormat>사용자 지정</PresentationFormat>
  <Paragraphs>10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박성근</cp:lastModifiedBy>
  <cp:revision>18</cp:revision>
  <dcterms:created xsi:type="dcterms:W3CDTF">2024-01-24T23:55:32Z</dcterms:created>
  <dcterms:modified xsi:type="dcterms:W3CDTF">2024-05-04T11:11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">
    <vt:lpwstr>NSCCustomProperty</vt:lpwstr>
  </property>
</Properties>
</file>